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4969DE5-8D0B-44C9-93BB-7D863771E46D}" v="4" dt="2025-11-20T07:48:40.3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85" autoAdjust="0"/>
    <p:restoredTop sz="94660"/>
  </p:normalViewPr>
  <p:slideViewPr>
    <p:cSldViewPr snapToGrid="0">
      <p:cViewPr>
        <p:scale>
          <a:sx n="75" d="100"/>
          <a:sy n="75" d="100"/>
        </p:scale>
        <p:origin x="2333" y="-10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鈴木隼人" userId="5f671c0f-60e4-4bc8-aa07-fca296af465c" providerId="ADAL" clId="{43F15EBA-0E6A-4052-99D2-1F82989880AE}"/>
    <pc:docChg chg="modSld">
      <pc:chgData name="鈴木隼人" userId="5f671c0f-60e4-4bc8-aa07-fca296af465c" providerId="ADAL" clId="{43F15EBA-0E6A-4052-99D2-1F82989880AE}" dt="2024-11-22T23:48:17.477" v="17" actId="20577"/>
      <pc:docMkLst>
        <pc:docMk/>
      </pc:docMkLst>
      <pc:sldChg chg="modSp mod">
        <pc:chgData name="鈴木隼人" userId="5f671c0f-60e4-4bc8-aa07-fca296af465c" providerId="ADAL" clId="{43F15EBA-0E6A-4052-99D2-1F82989880AE}" dt="2024-11-22T23:48:17.477" v="17" actId="20577"/>
        <pc:sldMkLst>
          <pc:docMk/>
          <pc:sldMk cId="602753361" sldId="256"/>
        </pc:sldMkLst>
      </pc:sldChg>
    </pc:docChg>
  </pc:docChgLst>
  <pc:docChgLst>
    <pc:chgData name="鈴木隼人" userId="5f671c0f-60e4-4bc8-aa07-fca296af465c" providerId="ADAL" clId="{755760AD-ACBA-47F1-B4A7-759D303C15CE}"/>
    <pc:docChg chg="undo custSel modSld">
      <pc:chgData name="鈴木隼人" userId="5f671c0f-60e4-4bc8-aa07-fca296af465c" providerId="ADAL" clId="{755760AD-ACBA-47F1-B4A7-759D303C15CE}" dt="2025-11-21T07:05:30.483" v="819" actId="20577"/>
      <pc:docMkLst>
        <pc:docMk/>
      </pc:docMkLst>
      <pc:sldChg chg="addSp delSp modSp mod">
        <pc:chgData name="鈴木隼人" userId="5f671c0f-60e4-4bc8-aa07-fca296af465c" providerId="ADAL" clId="{755760AD-ACBA-47F1-B4A7-759D303C15CE}" dt="2025-11-21T07:05:30.483" v="819" actId="20577"/>
        <pc:sldMkLst>
          <pc:docMk/>
          <pc:sldMk cId="602753361" sldId="256"/>
        </pc:sldMkLst>
        <pc:spChg chg="add mod">
          <ac:chgData name="鈴木隼人" userId="5f671c0f-60e4-4bc8-aa07-fca296af465c" providerId="ADAL" clId="{755760AD-ACBA-47F1-B4A7-759D303C15CE}" dt="2025-11-20T08:07:37.511" v="793" actId="1076"/>
          <ac:spMkLst>
            <pc:docMk/>
            <pc:sldMk cId="602753361" sldId="256"/>
            <ac:spMk id="2" creationId="{E8AACDFD-2122-4428-2DA0-D39255A8BC2B}"/>
          </ac:spMkLst>
        </pc:spChg>
        <pc:spChg chg="mod">
          <ac:chgData name="鈴木隼人" userId="5f671c0f-60e4-4bc8-aa07-fca296af465c" providerId="ADAL" clId="{755760AD-ACBA-47F1-B4A7-759D303C15CE}" dt="2025-11-21T07:05:30.483" v="819" actId="20577"/>
          <ac:spMkLst>
            <pc:docMk/>
            <pc:sldMk cId="602753361" sldId="256"/>
            <ac:spMk id="14" creationId="{A99A9A23-ACC5-03D7-364E-5A701ED4D69D}"/>
          </ac:spMkLst>
        </pc:spChg>
        <pc:spChg chg="mod">
          <ac:chgData name="鈴木隼人" userId="5f671c0f-60e4-4bc8-aa07-fca296af465c" providerId="ADAL" clId="{755760AD-ACBA-47F1-B4A7-759D303C15CE}" dt="2025-11-20T08:00:30.748" v="517" actId="1076"/>
          <ac:spMkLst>
            <pc:docMk/>
            <pc:sldMk cId="602753361" sldId="256"/>
            <ac:spMk id="24" creationId="{FCC37EDA-2852-FCFD-67FE-007F92981DBB}"/>
          </ac:spMkLst>
        </pc:spChg>
        <pc:spChg chg="mod ord">
          <ac:chgData name="鈴木隼人" userId="5f671c0f-60e4-4bc8-aa07-fca296af465c" providerId="ADAL" clId="{755760AD-ACBA-47F1-B4A7-759D303C15CE}" dt="2025-11-20T08:08:25.335" v="803" actId="1076"/>
          <ac:spMkLst>
            <pc:docMk/>
            <pc:sldMk cId="602753361" sldId="256"/>
            <ac:spMk id="25" creationId="{0C5004DF-B5A9-DA69-1811-DB58DBC752DE}"/>
          </ac:spMkLst>
        </pc:spChg>
        <pc:spChg chg="mod">
          <ac:chgData name="鈴木隼人" userId="5f671c0f-60e4-4bc8-aa07-fca296af465c" providerId="ADAL" clId="{755760AD-ACBA-47F1-B4A7-759D303C15CE}" dt="2025-11-20T08:08:32.261" v="805" actId="1076"/>
          <ac:spMkLst>
            <pc:docMk/>
            <pc:sldMk cId="602753361" sldId="256"/>
            <ac:spMk id="26" creationId="{4B16C6D0-C064-A6D6-5CEB-996E57DAFCC1}"/>
          </ac:spMkLst>
        </pc:spChg>
        <pc:spChg chg="del mod">
          <ac:chgData name="鈴木隼人" userId="5f671c0f-60e4-4bc8-aa07-fca296af465c" providerId="ADAL" clId="{755760AD-ACBA-47F1-B4A7-759D303C15CE}" dt="2025-11-20T08:08:04.319" v="799" actId="478"/>
          <ac:spMkLst>
            <pc:docMk/>
            <pc:sldMk cId="602753361" sldId="256"/>
            <ac:spMk id="27" creationId="{67D99B3A-3317-61E5-0A93-C1996E22D2D8}"/>
          </ac:spMkLst>
        </pc:spChg>
        <pc:picChg chg="add mod">
          <ac:chgData name="鈴木隼人" userId="5f671c0f-60e4-4bc8-aa07-fca296af465c" providerId="ADAL" clId="{755760AD-ACBA-47F1-B4A7-759D303C15CE}" dt="2025-11-20T08:12:23.235" v="811" actId="1076"/>
          <ac:picMkLst>
            <pc:docMk/>
            <pc:sldMk cId="602753361" sldId="256"/>
            <ac:picMk id="4" creationId="{F69FF503-9BA4-9434-F676-AAF02447BC47}"/>
          </ac:picMkLst>
        </pc:picChg>
        <pc:picChg chg="add mod">
          <ac:chgData name="鈴木隼人" userId="5f671c0f-60e4-4bc8-aa07-fca296af465c" providerId="ADAL" clId="{755760AD-ACBA-47F1-B4A7-759D303C15CE}" dt="2025-11-20T08:00:12.566" v="514" actId="552"/>
          <ac:picMkLst>
            <pc:docMk/>
            <pc:sldMk cId="602753361" sldId="256"/>
            <ac:picMk id="7" creationId="{BEEFCF4E-37B6-4F63-D61E-418B637D1191}"/>
          </ac:picMkLst>
        </pc:picChg>
        <pc:picChg chg="add mod ord">
          <ac:chgData name="鈴木隼人" userId="5f671c0f-60e4-4bc8-aa07-fca296af465c" providerId="ADAL" clId="{755760AD-ACBA-47F1-B4A7-759D303C15CE}" dt="2025-11-20T08:00:12.566" v="514" actId="552"/>
          <ac:picMkLst>
            <pc:docMk/>
            <pc:sldMk cId="602753361" sldId="256"/>
            <ac:picMk id="9" creationId="{D52221D1-5841-2930-2429-41BFD87F7B15}"/>
          </ac:picMkLst>
        </pc:picChg>
        <pc:picChg chg="mod ord">
          <ac:chgData name="鈴木隼人" userId="5f671c0f-60e4-4bc8-aa07-fca296af465c" providerId="ADAL" clId="{755760AD-ACBA-47F1-B4A7-759D303C15CE}" dt="2025-11-20T08:08:20.015" v="802" actId="1076"/>
          <ac:picMkLst>
            <pc:docMk/>
            <pc:sldMk cId="602753361" sldId="256"/>
            <ac:picMk id="11" creationId="{240E4EDD-D28E-1397-1FDE-AE37DC234D53}"/>
          </ac:picMkLst>
        </pc:picChg>
        <pc:picChg chg="mod">
          <ac:chgData name="鈴木隼人" userId="5f671c0f-60e4-4bc8-aa07-fca296af465c" providerId="ADAL" clId="{755760AD-ACBA-47F1-B4A7-759D303C15CE}" dt="2025-11-20T08:08:28.748" v="804" actId="1076"/>
          <ac:picMkLst>
            <pc:docMk/>
            <pc:sldMk cId="602753361" sldId="256"/>
            <ac:picMk id="12" creationId="{45E195E0-90DA-DB1E-C045-C882B776898D}"/>
          </ac:picMkLst>
        </pc:picChg>
        <pc:picChg chg="mod">
          <ac:chgData name="鈴木隼人" userId="5f671c0f-60e4-4bc8-aa07-fca296af465c" providerId="ADAL" clId="{755760AD-ACBA-47F1-B4A7-759D303C15CE}" dt="2025-11-20T08:08:36.548" v="806" actId="1076"/>
          <ac:picMkLst>
            <pc:docMk/>
            <pc:sldMk cId="602753361" sldId="256"/>
            <ac:picMk id="13" creationId="{51802C53-192B-DB59-9AEC-EB4E51E9FC64}"/>
          </ac:picMkLst>
        </pc:picChg>
        <pc:picChg chg="add mod">
          <ac:chgData name="鈴木隼人" userId="5f671c0f-60e4-4bc8-aa07-fca296af465c" providerId="ADAL" clId="{755760AD-ACBA-47F1-B4A7-759D303C15CE}" dt="2025-11-20T08:00:12.566" v="514" actId="552"/>
          <ac:picMkLst>
            <pc:docMk/>
            <pc:sldMk cId="602753361" sldId="256"/>
            <ac:picMk id="15" creationId="{95406A75-5859-A03F-7E93-A982A6E0EF7D}"/>
          </ac:picMkLst>
        </pc:picChg>
        <pc:picChg chg="add mod">
          <ac:chgData name="鈴木隼人" userId="5f671c0f-60e4-4bc8-aa07-fca296af465c" providerId="ADAL" clId="{755760AD-ACBA-47F1-B4A7-759D303C15CE}" dt="2025-11-20T08:00:12.566" v="514" actId="552"/>
          <ac:picMkLst>
            <pc:docMk/>
            <pc:sldMk cId="602753361" sldId="256"/>
            <ac:picMk id="17" creationId="{8DFA5945-391A-795E-7865-499586575CDE}"/>
          </ac:picMkLst>
        </pc:picChg>
      </pc:sldChg>
    </pc:docChg>
  </pc:docChgLst>
  <pc:docChgLst>
    <pc:chgData name="鈴木隼人" userId="5f671c0f-60e4-4bc8-aa07-fca296af465c" providerId="ADAL" clId="{1912A71E-9102-43A9-B655-DCF7BA0A737B}"/>
    <pc:docChg chg="undo custSel addSld modSld">
      <pc:chgData name="鈴木隼人" userId="5f671c0f-60e4-4bc8-aa07-fca296af465c" providerId="ADAL" clId="{1912A71E-9102-43A9-B655-DCF7BA0A737B}" dt="2024-10-29T00:59:57.473" v="212" actId="1076"/>
      <pc:docMkLst>
        <pc:docMk/>
      </pc:docMkLst>
      <pc:sldChg chg="addSp delSp modSp new mod">
        <pc:chgData name="鈴木隼人" userId="5f671c0f-60e4-4bc8-aa07-fca296af465c" providerId="ADAL" clId="{1912A71E-9102-43A9-B655-DCF7BA0A737B}" dt="2024-10-29T00:59:57.473" v="212" actId="1076"/>
        <pc:sldMkLst>
          <pc:docMk/>
          <pc:sldMk cId="602753361" sldId="256"/>
        </pc:sldMkLst>
      </pc:sldChg>
    </pc:docChg>
  </pc:docChgLst>
  <pc:docChgLst>
    <pc:chgData name="鈴木隼人" userId="5f671c0f-60e4-4bc8-aa07-fca296af465c" providerId="ADAL" clId="{7EEC835D-C206-4F2B-8843-5A8EEE1CC90F}"/>
    <pc:docChg chg="undo custSel modSld">
      <pc:chgData name="鈴木隼人" userId="5f671c0f-60e4-4bc8-aa07-fca296af465c" providerId="ADAL" clId="{7EEC835D-C206-4F2B-8843-5A8EEE1CC90F}" dt="2024-11-18T06:42:58.506" v="58" actId="1076"/>
      <pc:docMkLst>
        <pc:docMk/>
      </pc:docMkLst>
      <pc:sldChg chg="addSp delSp modSp mod">
        <pc:chgData name="鈴木隼人" userId="5f671c0f-60e4-4bc8-aa07-fca296af465c" providerId="ADAL" clId="{7EEC835D-C206-4F2B-8843-5A8EEE1CC90F}" dt="2024-11-18T06:42:58.506" v="58" actId="1076"/>
        <pc:sldMkLst>
          <pc:docMk/>
          <pc:sldMk cId="602753361" sldId="256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9981DA-D008-4DCA-BAFD-CAE109E7AEC0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B73EE4-B132-4B33-A99C-0DA4F931E5D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830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2B73EE4-B132-4B33-A99C-0DA4F931E5D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680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042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2730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8343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575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99382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89777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156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9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2690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0692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349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AA3A4D-F7E4-409D-AD76-7EF3FB2E23A3}" type="datetimeFigureOut">
              <a:rPr kumimoji="1" lang="ja-JP" altLang="en-US" smtClean="0"/>
              <a:t>2025/1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4C89FC-A45D-46CB-870A-4669F83816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51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D52221D1-5841-2930-2429-41BFD87F7B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968" y="959965"/>
            <a:ext cx="2455467" cy="1419215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99A9A23-ACC5-03D7-364E-5A701ED4D69D}"/>
              </a:ext>
            </a:extLst>
          </p:cNvPr>
          <p:cNvSpPr txBox="1"/>
          <p:nvPr/>
        </p:nvSpPr>
        <p:spPr>
          <a:xfrm>
            <a:off x="185952" y="7720090"/>
            <a:ext cx="6400801" cy="10564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1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ry Figure S1. Output data of the pipeline. 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epresentative images of plasmid assembly report (a</a:t>
            </a:r>
            <a:r>
              <a:rPr lang="en-US" altLang="ja-JP" sz="110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), </a:t>
            </a:r>
            <a:r>
              <a:rPr lang="en-US" altLang="ja-JP" sz="1100">
                <a:latin typeface="Times New Roman" panose="02020603050405020304" pitchFamily="18" charset="0"/>
                <a:ea typeface="Times New Roman" panose="02020603050405020304" pitchFamily="18" charset="0"/>
              </a:rPr>
              <a:t>metrics </a:t>
            </a:r>
            <a:r>
              <a:rPr lang="en-US" altLang="ja-JP" sz="11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o show quality of sequencing and assembly (b), coverage plot (c), mutation plot (d), output of an annotated plasmid map (e).</a:t>
            </a:r>
          </a:p>
        </p:txBody>
      </p:sp>
      <p:pic>
        <p:nvPicPr>
          <p:cNvPr id="12" name="image15.png">
            <a:extLst>
              <a:ext uri="{FF2B5EF4-FFF2-40B4-BE49-F238E27FC236}">
                <a16:creationId xmlns:a16="http://schemas.microsoft.com/office/drawing/2014/main" id="{45E195E0-90DA-DB1E-C045-C882B776898D}"/>
              </a:ext>
            </a:extLst>
          </p:cNvPr>
          <p:cNvPicPr/>
          <p:nvPr/>
        </p:nvPicPr>
        <p:blipFill>
          <a:blip r:embed="rId4"/>
          <a:srcRect/>
          <a:stretch>
            <a:fillRect/>
          </a:stretch>
        </p:blipFill>
        <p:spPr>
          <a:xfrm>
            <a:off x="3318412" y="2865572"/>
            <a:ext cx="2960606" cy="1600860"/>
          </a:xfrm>
          <a:prstGeom prst="rect">
            <a:avLst/>
          </a:prstGeom>
          <a:ln/>
        </p:spPr>
      </p:pic>
      <p:pic>
        <p:nvPicPr>
          <p:cNvPr id="13" name="image13.png">
            <a:extLst>
              <a:ext uri="{FF2B5EF4-FFF2-40B4-BE49-F238E27FC236}">
                <a16:creationId xmlns:a16="http://schemas.microsoft.com/office/drawing/2014/main" id="{51802C53-192B-DB59-9AEC-EB4E51E9FC64}"/>
              </a:ext>
            </a:extLst>
          </p:cNvPr>
          <p:cNvPicPr/>
          <p:nvPr/>
        </p:nvPicPr>
        <p:blipFill>
          <a:blip r:embed="rId5"/>
          <a:srcRect/>
          <a:stretch>
            <a:fillRect/>
          </a:stretch>
        </p:blipFill>
        <p:spPr>
          <a:xfrm>
            <a:off x="3565587" y="4846655"/>
            <a:ext cx="2713431" cy="2717968"/>
          </a:xfrm>
          <a:prstGeom prst="rect">
            <a:avLst/>
          </a:prstGeom>
          <a:ln/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58589F42-D7C5-D9AD-8497-8F7CCA7831E7}"/>
              </a:ext>
            </a:extLst>
          </p:cNvPr>
          <p:cNvSpPr txBox="1"/>
          <p:nvPr/>
        </p:nvSpPr>
        <p:spPr>
          <a:xfrm>
            <a:off x="385010" y="503622"/>
            <a:ext cx="491958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(a)</a:t>
            </a:r>
            <a:endParaRPr lang="ja-JP" altLang="ja-JP" sz="1400" b="1" dirty="0">
              <a:effectLst/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CC37EDA-2852-FCFD-67FE-007F92981DBB}"/>
              </a:ext>
            </a:extLst>
          </p:cNvPr>
          <p:cNvSpPr txBox="1"/>
          <p:nvPr/>
        </p:nvSpPr>
        <p:spPr>
          <a:xfrm>
            <a:off x="385010" y="5195901"/>
            <a:ext cx="491958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(b)</a:t>
            </a:r>
            <a:endParaRPr lang="ja-JP" altLang="ja-JP" sz="1400" b="1" dirty="0">
              <a:effectLst/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B16C6D0-C064-A6D6-5CEB-996E57DAFCC1}"/>
              </a:ext>
            </a:extLst>
          </p:cNvPr>
          <p:cNvSpPr txBox="1"/>
          <p:nvPr/>
        </p:nvSpPr>
        <p:spPr>
          <a:xfrm>
            <a:off x="3056910" y="4345032"/>
            <a:ext cx="491958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(e)</a:t>
            </a:r>
            <a:endParaRPr lang="ja-JP" altLang="ja-JP" sz="1400" b="1" dirty="0">
              <a:effectLst/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pic>
        <p:nvPicPr>
          <p:cNvPr id="7" name="図 6" descr="グラフ, 棒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BEEFCF4E-37B6-4F63-D61E-418B637D119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968" y="3008865"/>
            <a:ext cx="2268313" cy="1701235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95406A75-5859-A03F-7E93-A982A6E0EF7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6968" y="2388357"/>
            <a:ext cx="2470487" cy="60448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8DFA5945-391A-795E-7865-499586575C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6968" y="4736572"/>
            <a:ext cx="2470487" cy="611989"/>
          </a:xfrm>
          <a:prstGeom prst="rect">
            <a:avLst/>
          </a:prstGeom>
        </p:spPr>
      </p:pic>
      <p:pic>
        <p:nvPicPr>
          <p:cNvPr id="11" name="image6.png">
            <a:extLst>
              <a:ext uri="{FF2B5EF4-FFF2-40B4-BE49-F238E27FC236}">
                <a16:creationId xmlns:a16="http://schemas.microsoft.com/office/drawing/2014/main" id="{240E4EDD-D28E-1397-1FDE-AE37DC234D53}"/>
              </a:ext>
            </a:extLst>
          </p:cNvPr>
          <p:cNvPicPr/>
          <p:nvPr/>
        </p:nvPicPr>
        <p:blipFill>
          <a:blip r:embed="rId9"/>
          <a:srcRect/>
          <a:stretch>
            <a:fillRect/>
          </a:stretch>
        </p:blipFill>
        <p:spPr>
          <a:xfrm>
            <a:off x="3318414" y="943539"/>
            <a:ext cx="2960604" cy="1541810"/>
          </a:xfrm>
          <a:prstGeom prst="rect">
            <a:avLst/>
          </a:prstGeom>
          <a:ln/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C5004DF-B5A9-DA69-1811-DB58DBC752DE}"/>
              </a:ext>
            </a:extLst>
          </p:cNvPr>
          <p:cNvSpPr txBox="1"/>
          <p:nvPr/>
        </p:nvSpPr>
        <p:spPr>
          <a:xfrm>
            <a:off x="3056910" y="2346402"/>
            <a:ext cx="491958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(d)</a:t>
            </a:r>
            <a:endParaRPr lang="ja-JP" altLang="ja-JP" sz="1400" b="1" dirty="0">
              <a:effectLst/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8AACDFD-2122-4428-2DA0-D39255A8BC2B}"/>
              </a:ext>
            </a:extLst>
          </p:cNvPr>
          <p:cNvSpPr txBox="1"/>
          <p:nvPr/>
        </p:nvSpPr>
        <p:spPr>
          <a:xfrm>
            <a:off x="3058414" y="500480"/>
            <a:ext cx="491958" cy="46262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Bef>
                <a:spcPts val="1200"/>
              </a:spcBef>
              <a:spcAft>
                <a:spcPts val="1200"/>
              </a:spcAft>
            </a:pP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(</a:t>
            </a:r>
            <a:r>
              <a:rPr lang="en-US" altLang="ja-JP" sz="1400" b="1" dirty="0">
                <a:latin typeface="Arial" panose="020B0604020202020204" pitchFamily="34" charset="0"/>
                <a:ea typeface="游明朝" panose="02020400000000000000" pitchFamily="18" charset="-128"/>
              </a:rPr>
              <a:t>c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)</a:t>
            </a:r>
            <a:endParaRPr lang="ja-JP" altLang="ja-JP" sz="1400" b="1" dirty="0">
              <a:effectLst/>
              <a:latin typeface="Arial" panose="020B0604020202020204" pitchFamily="34" charset="0"/>
              <a:ea typeface="游明朝" panose="02020400000000000000" pitchFamily="18" charset="-128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F69FF503-9BA4-9434-F676-AAF02447BC4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0989" y="5721460"/>
            <a:ext cx="2500720" cy="17239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2753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65</Words>
  <Application>Microsoft Office PowerPoint</Application>
  <PresentationFormat>A4 210 x 297 mm</PresentationFormat>
  <Paragraphs>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鈴木隼人</dc:creator>
  <cp:lastModifiedBy>鈴木隼人</cp:lastModifiedBy>
  <cp:revision>3</cp:revision>
  <dcterms:created xsi:type="dcterms:W3CDTF">2024-10-29T00:54:38Z</dcterms:created>
  <dcterms:modified xsi:type="dcterms:W3CDTF">2025-11-21T07:05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4-11-18T06:37:46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feee744d-0aad-47f1-808a-a219806bc820</vt:lpwstr>
  </property>
  <property fmtid="{D5CDD505-2E9C-101B-9397-08002B2CF9AE}" pid="8" name="MSIP_Label_ddc55989-3c9e-4466-8514-eac6f80f6373_ContentBits">
    <vt:lpwstr>0</vt:lpwstr>
  </property>
</Properties>
</file>